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0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648912" y="2040426"/>
            <a:ext cx="10376291" cy="5761219"/>
            <a:chOff x="2467708" y="2487238"/>
            <a:chExt cx="10376291" cy="5761219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67708" y="2487238"/>
              <a:ext cx="10376291" cy="576121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3238333" y="665198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3803940" y="669009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521136" y="6728011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081675" y="6777636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943113" y="6810191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382269" y="670845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660004" y="670246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643301" y="6372044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209002" y="611860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5922784" y="624073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6488454" y="597866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6343412" y="6010094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6065423" y="621806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5784008" y="6172944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4438040" y="7468457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003647" y="7373867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4726159" y="7459417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286698" y="7376137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5148136" y="735552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4587292" y="745580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859711" y="746045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6841915" y="519379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7407217" y="500820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7124566" y="506998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7689104" y="490524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7545779" y="492351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6985240" y="5031234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7267891" y="5038783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8042846" y="277063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8608453" y="301352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8325649" y="296095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8890951" y="3220131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8752389" y="325269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8158203" y="2927106"/>
              <a:ext cx="3462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C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8469280" y="289255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0445035" y="6182470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1007239" y="640251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0723755" y="624527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1265922" y="6370993"/>
              <a:ext cx="3362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D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1146412" y="633210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10591553" y="6263347"/>
              <a:ext cx="175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0863336" y="632963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9238640" y="776807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9804247" y="7725874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9526759" y="7763791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10092061" y="769003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9948736" y="770753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9383129" y="7760186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9660311" y="7764836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11634629" y="776401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12200236" y="7764682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11922748" y="7764495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12488050" y="772884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2344725" y="7727288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11779118" y="7765659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12056300" y="7765547"/>
              <a:ext cx="1978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</p:grpSp>
      <p:sp>
        <p:nvSpPr>
          <p:cNvPr id="62" name="文本框 61"/>
          <p:cNvSpPr txBox="1"/>
          <p:nvPr/>
        </p:nvSpPr>
        <p:spPr>
          <a:xfrm>
            <a:off x="2651852" y="8182960"/>
            <a:ext cx="103762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ffe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s on seed fatty acid composition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fatty acid composition was measured by gas chromatography, and calculated based on the peak area. Values are means ± SE (n=3). Capital letters indicates a significant difference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 based o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nca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</a:t>
            </a:r>
          </a:p>
        </p:txBody>
      </p:sp>
    </p:spTree>
    <p:extLst>
      <p:ext uri="{BB962C8B-B14F-4D97-AF65-F5344CB8AC3E}">
        <p14:creationId xmlns:p14="http://schemas.microsoft.com/office/powerpoint/2010/main" val="2482784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115</Words>
  <Application>Microsoft Office PowerPoint</Application>
  <PresentationFormat>Custom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37:49Z</dcterms:modified>
</cp:coreProperties>
</file>